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5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E850A-1132-4767-98B9-6E48B061B7C9}" type="datetimeFigureOut">
              <a:rPr lang="fr-FR" smtClean="0"/>
              <a:t>27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EAA97-E8FD-4628-9CAA-B14B76D9E61A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55576" y="3471143"/>
            <a:ext cx="7772400" cy="677937"/>
          </a:xfrm>
        </p:spPr>
        <p:txBody>
          <a:bodyPr anchor="t">
            <a:normAutofit/>
          </a:bodyPr>
          <a:lstStyle/>
          <a:p>
            <a:pPr algn="l"/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Bacteria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classifi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as R: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resistant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, I: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intermediate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or S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susceptible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according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to French national guidelines </a:t>
            </a:r>
            <a:br>
              <a:rPr lang="fr-FR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(Comité de l’antibiogramme de la Société Française de Microbiologie, CA-SFM, 2012).</a:t>
            </a:r>
            <a:br>
              <a:rPr lang="fr-FR" sz="1200" dirty="0" smtClean="0">
                <a:latin typeface="Times New Roman" pitchFamily="18" charset="0"/>
                <a:cs typeface="Times New Roman" pitchFamily="18" charset="0"/>
              </a:rPr>
            </a:b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5902597"/>
              </p:ext>
            </p:extLst>
          </p:nvPr>
        </p:nvGraphicFramePr>
        <p:xfrm>
          <a:off x="323526" y="2039248"/>
          <a:ext cx="8280926" cy="1198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64098"/>
                <a:gridCol w="403881"/>
                <a:gridCol w="435309"/>
                <a:gridCol w="475492"/>
                <a:gridCol w="475492"/>
                <a:gridCol w="554740"/>
                <a:gridCol w="475492"/>
                <a:gridCol w="475492"/>
                <a:gridCol w="475492"/>
                <a:gridCol w="475492"/>
                <a:gridCol w="475492"/>
                <a:gridCol w="396243"/>
                <a:gridCol w="475492"/>
                <a:gridCol w="475492"/>
                <a:gridCol w="475492"/>
                <a:gridCol w="396243"/>
                <a:gridCol w="475492"/>
              </a:tblGrid>
              <a:tr h="432048">
                <a:tc>
                  <a:txBody>
                    <a:bodyPr/>
                    <a:lstStyle/>
                    <a:p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         </a:t>
                      </a:r>
                      <a:r>
                        <a:rPr lang="fr-FR" sz="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ntibiotic</a:t>
                      </a:r>
                      <a:endParaRPr lang="fr-FR" sz="8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                  (µg)</a:t>
                      </a:r>
                    </a:p>
                    <a:p>
                      <a:r>
                        <a:rPr lang="fr-FR" sz="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Strain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TIC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75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PRL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75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T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5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IPM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ATM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TOB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G</a:t>
                      </a:r>
                      <a:r>
                        <a:rPr lang="fr-FR" sz="800" b="1" smtClean="0">
                          <a:latin typeface="Times New Roman" pitchFamily="18" charset="0"/>
                          <a:cs typeface="Times New Roman" pitchFamily="18" charset="0"/>
                        </a:rPr>
                        <a:t>N</a:t>
                      </a:r>
                      <a:endParaRPr lang="fr-FR" sz="800" b="1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AK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TIM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85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AZ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IP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FS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LEV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SXT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FF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5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smtClean="0">
                          <a:latin typeface="Times New Roman" pitchFamily="18" charset="0"/>
                          <a:cs typeface="Times New Roman" pitchFamily="18" charset="0"/>
                        </a:rPr>
                        <a:t>NET</a:t>
                      </a:r>
                    </a:p>
                    <a:p>
                      <a:pPr algn="ctr"/>
                      <a:r>
                        <a:rPr lang="fr-FR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TCC BAA-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MFY161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  <a:endParaRPr lang="fr-FR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cxnSp>
        <p:nvCxnSpPr>
          <p:cNvPr id="9" name="Connecteur droit 8"/>
          <p:cNvCxnSpPr/>
          <p:nvPr/>
        </p:nvCxnSpPr>
        <p:spPr>
          <a:xfrm>
            <a:off x="323528" y="2060848"/>
            <a:ext cx="792088" cy="43204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ZoneTexte 2"/>
          <p:cNvSpPr txBox="1"/>
          <p:nvPr/>
        </p:nvSpPr>
        <p:spPr>
          <a:xfrm>
            <a:off x="683568" y="589284"/>
            <a:ext cx="75608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S1.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Antibiotic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susceptibility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pattern of 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mosselii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ATCC BAA-99 and 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mosselii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MFY161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antibiotics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test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ticarcill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TIC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piperacill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PRL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colistin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(CT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imipenem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IPM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aztreonam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ATM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tobramyc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TOB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gentamyc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GN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amikac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AK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ticarcillin+clavulanic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aci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TIM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ceftazidim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CAZ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ciprofloxac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CIP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cefsulod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CFS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levofloxac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LEV),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trimethoprim-sulphamethoxazole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(SXT)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fosfomyci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FF) and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netilmicin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NET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82</Words>
  <Application>Microsoft Office PowerPoint</Application>
  <PresentationFormat>Affichage à l'écran (4:3)</PresentationFormat>
  <Paragraphs>7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Bacteria were classified as R: resistant, I: intermediate or S: susceptible according to French national guidelines  (Comité de l’antibiogramme de la Société Française de Microbiologie, CA-SFM, 2012).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tibiogram</dc:title>
  <dc:creator>LENEVEU</dc:creator>
  <cp:lastModifiedBy>LMSM - C209</cp:lastModifiedBy>
  <cp:revision>9</cp:revision>
  <dcterms:created xsi:type="dcterms:W3CDTF">2013-03-01T15:40:40Z</dcterms:created>
  <dcterms:modified xsi:type="dcterms:W3CDTF">2013-05-27T16:04:40Z</dcterms:modified>
</cp:coreProperties>
</file>